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6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marx\Desktop\SaOS-2%20Kombination%20AUY322%20+%20VE821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cmarx\Desktop\SaOS-2%20Kombination%20AUY322%20+%20VE821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cmarx\Desktop\SaOS-2%20Kombination%20AUY322%20+%20KU5593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marx\Desktop\SaOS-2%20Kombination%20AUY322%20+%20KU5593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865157480314957"/>
          <c:y val="6.1111111111111109E-2"/>
          <c:w val="0.69877898075240596"/>
          <c:h val="0.72524059492563431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VE821.xlsx]PI'!$H$49:$M$49</c:f>
                <c:numCache>
                  <c:formatCode>General</c:formatCode>
                  <c:ptCount val="6"/>
                  <c:pt idx="0">
                    <c:v>2.7111111111111108</c:v>
                  </c:pt>
                  <c:pt idx="1">
                    <c:v>0.28888888888888847</c:v>
                  </c:pt>
                  <c:pt idx="2">
                    <c:v>0.93333333333333235</c:v>
                  </c:pt>
                  <c:pt idx="3">
                    <c:v>2.8222222222222229</c:v>
                  </c:pt>
                  <c:pt idx="4">
                    <c:v>1.8000000000000018</c:v>
                  </c:pt>
                  <c:pt idx="5">
                    <c:v>2.3111111111111122</c:v>
                  </c:pt>
                </c:numCache>
              </c:numRef>
            </c:plus>
            <c:minus>
              <c:numRef>
                <c:f>'[SaOS-2 Kombination AUY322 + VE821.xlsx]PI'!$H$49:$M$49</c:f>
                <c:numCache>
                  <c:formatCode>General</c:formatCode>
                  <c:ptCount val="6"/>
                  <c:pt idx="0">
                    <c:v>2.7111111111111108</c:v>
                  </c:pt>
                  <c:pt idx="1">
                    <c:v>0.28888888888888847</c:v>
                  </c:pt>
                  <c:pt idx="2">
                    <c:v>0.93333333333333235</c:v>
                  </c:pt>
                  <c:pt idx="3">
                    <c:v>2.8222222222222229</c:v>
                  </c:pt>
                  <c:pt idx="4">
                    <c:v>1.8000000000000018</c:v>
                  </c:pt>
                  <c:pt idx="5">
                    <c:v>2.3111111111111122</c:v>
                  </c:pt>
                </c:numCache>
              </c:numRef>
            </c:minus>
          </c:errBars>
          <c:xVal>
            <c:numRef>
              <c:f>'[SaOS-2 Kombination AUY322 + VE821.xlsx]PI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VE821.xlsx]PI'!$R$43:$R$48</c:f>
              <c:numCache>
                <c:formatCode>0.0</c:formatCode>
                <c:ptCount val="6"/>
                <c:pt idx="0">
                  <c:v>11.633333333333333</c:v>
                </c:pt>
                <c:pt idx="1">
                  <c:v>14.833333333333334</c:v>
                </c:pt>
                <c:pt idx="2">
                  <c:v>20.000000000000004</c:v>
                </c:pt>
                <c:pt idx="3">
                  <c:v>33.233333333333334</c:v>
                </c:pt>
                <c:pt idx="4">
                  <c:v>38.199999999999996</c:v>
                </c:pt>
                <c:pt idx="5">
                  <c:v>40.36666666666666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D0A-4ACA-9459-AD770DAF79F6}"/>
            </c:ext>
          </c:extLst>
        </c:ser>
        <c:ser>
          <c:idx val="1"/>
          <c:order val="1"/>
          <c:tx>
            <c:v>2 µM VE821</c:v>
          </c:tx>
          <c:spPr>
            <a:ln w="9525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VE821.xlsx]PI'!$H$50:$M$50</c:f>
                <c:numCache>
                  <c:formatCode>General</c:formatCode>
                  <c:ptCount val="6"/>
                  <c:pt idx="0">
                    <c:v>2.1111111111111107</c:v>
                  </c:pt>
                  <c:pt idx="1">
                    <c:v>1.9555555555555557</c:v>
                  </c:pt>
                  <c:pt idx="2">
                    <c:v>1.333333333333331</c:v>
                  </c:pt>
                  <c:pt idx="3">
                    <c:v>2.7999999999999994</c:v>
                  </c:pt>
                  <c:pt idx="4">
                    <c:v>2.5555555555555571</c:v>
                  </c:pt>
                  <c:pt idx="5">
                    <c:v>2.7111111111111135</c:v>
                  </c:pt>
                </c:numCache>
              </c:numRef>
            </c:plus>
            <c:minus>
              <c:numRef>
                <c:f>'[SaOS-2 Kombination AUY322 + VE821.xlsx]PI'!$H$50:$M$50</c:f>
                <c:numCache>
                  <c:formatCode>General</c:formatCode>
                  <c:ptCount val="6"/>
                  <c:pt idx="0">
                    <c:v>2.1111111111111107</c:v>
                  </c:pt>
                  <c:pt idx="1">
                    <c:v>1.9555555555555557</c:v>
                  </c:pt>
                  <c:pt idx="2">
                    <c:v>1.333333333333331</c:v>
                  </c:pt>
                  <c:pt idx="3">
                    <c:v>2.7999999999999994</c:v>
                  </c:pt>
                  <c:pt idx="4">
                    <c:v>2.5555555555555571</c:v>
                  </c:pt>
                  <c:pt idx="5">
                    <c:v>2.7111111111111135</c:v>
                  </c:pt>
                </c:numCache>
              </c:numRef>
            </c:minus>
          </c:errBars>
          <c:xVal>
            <c:numRef>
              <c:f>'[SaOS-2 Kombination AUY322 + VE821.xlsx]PI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VE821.xlsx]PI'!$U$43:$U$48</c:f>
              <c:numCache>
                <c:formatCode>0.0</c:formatCode>
                <c:ptCount val="6"/>
                <c:pt idx="0">
                  <c:v>16.966666666666669</c:v>
                </c:pt>
                <c:pt idx="1">
                  <c:v>20.933333333333334</c:v>
                </c:pt>
                <c:pt idx="2">
                  <c:v>30.600000000000005</c:v>
                </c:pt>
                <c:pt idx="3">
                  <c:v>39.1</c:v>
                </c:pt>
                <c:pt idx="4">
                  <c:v>43.233333333333327</c:v>
                </c:pt>
                <c:pt idx="5">
                  <c:v>44.16666666666666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D0A-4ACA-9459-AD770DAF79F6}"/>
            </c:ext>
          </c:extLst>
        </c:ser>
        <c:ser>
          <c:idx val="2"/>
          <c:order val="2"/>
          <c:tx>
            <c:v>5 µM VE281</c:v>
          </c:tx>
          <c:spPr>
            <a:ln w="9525">
              <a:solidFill>
                <a:srgbClr val="FF0000"/>
              </a:solidFill>
            </a:ln>
          </c:spPr>
          <c:marker>
            <c:symbol val="square"/>
            <c:size val="5"/>
            <c:spPr>
              <a:noFill/>
              <a:ln w="19050"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VE821.xlsx]PI'!$H$51:$M$51</c:f>
                <c:numCache>
                  <c:formatCode>General</c:formatCode>
                  <c:ptCount val="6"/>
                  <c:pt idx="0">
                    <c:v>0.844444444444445</c:v>
                  </c:pt>
                  <c:pt idx="1">
                    <c:v>0.35555555555555668</c:v>
                  </c:pt>
                  <c:pt idx="2">
                    <c:v>0.5555555555555548</c:v>
                  </c:pt>
                  <c:pt idx="3">
                    <c:v>2</c:v>
                  </c:pt>
                  <c:pt idx="4">
                    <c:v>1</c:v>
                  </c:pt>
                  <c:pt idx="5">
                    <c:v>1.4444444444444475</c:v>
                  </c:pt>
                </c:numCache>
              </c:numRef>
            </c:plus>
            <c:minus>
              <c:numRef>
                <c:f>'[SaOS-2 Kombination AUY322 + VE821.xlsx]PI'!$H$51:$M$51</c:f>
                <c:numCache>
                  <c:formatCode>General</c:formatCode>
                  <c:ptCount val="6"/>
                  <c:pt idx="0">
                    <c:v>0.844444444444445</c:v>
                  </c:pt>
                  <c:pt idx="1">
                    <c:v>0.35555555555555668</c:v>
                  </c:pt>
                  <c:pt idx="2">
                    <c:v>0.5555555555555548</c:v>
                  </c:pt>
                  <c:pt idx="3">
                    <c:v>2</c:v>
                  </c:pt>
                  <c:pt idx="4">
                    <c:v>1</c:v>
                  </c:pt>
                  <c:pt idx="5">
                    <c:v>1.4444444444444475</c:v>
                  </c:pt>
                </c:numCache>
              </c:numRef>
            </c:minus>
          </c:errBars>
          <c:xVal>
            <c:numRef>
              <c:f>'[SaOS-2 Kombination AUY322 + VE821.xlsx]PI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VE821.xlsx]PI'!$X$43:$X$48</c:f>
              <c:numCache>
                <c:formatCode>0.0</c:formatCode>
                <c:ptCount val="6"/>
                <c:pt idx="0">
                  <c:v>28.933333333333334</c:v>
                </c:pt>
                <c:pt idx="1">
                  <c:v>36.366666666666667</c:v>
                </c:pt>
                <c:pt idx="2">
                  <c:v>42.666666666666664</c:v>
                </c:pt>
                <c:pt idx="3">
                  <c:v>47.699999999999996</c:v>
                </c:pt>
                <c:pt idx="4">
                  <c:v>50.800000000000004</c:v>
                </c:pt>
                <c:pt idx="5">
                  <c:v>51.46666666666666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FD0A-4ACA-9459-AD770DAF79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9388928"/>
        <c:axId val="83404288"/>
      </c:scatterChart>
      <c:valAx>
        <c:axId val="89388928"/>
        <c:scaling>
          <c:orientation val="minMax"/>
          <c:max val="6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83404288"/>
        <c:crosses val="autoZero"/>
        <c:crossBetween val="midCat"/>
        <c:majorUnit val="15"/>
        <c:minorUnit val="4"/>
      </c:valAx>
      <c:valAx>
        <c:axId val="83404288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death (%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89388928"/>
        <c:crosses val="autoZero"/>
        <c:crossBetween val="midCat"/>
        <c:majorUnit val="25"/>
        <c:minorUnit val="2"/>
      </c:valAx>
    </c:plotArea>
    <c:legend>
      <c:legendPos val="tr"/>
      <c:layout>
        <c:manualLayout>
          <c:xMode val="edge"/>
          <c:yMode val="edge"/>
          <c:x val="0.30555555555555558"/>
          <c:y val="0"/>
          <c:w val="0.69444444444444453"/>
          <c:h val="0.22187882764654415"/>
        </c:manualLayout>
      </c:layout>
      <c:overlay val="1"/>
    </c:legend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865157480314957"/>
          <c:y val="6.1111111111111109E-2"/>
          <c:w val="0.69877898075240596"/>
          <c:h val="0.72524059492563431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VE821.xlsx]DiOC'!$H$49:$M$49</c:f>
                <c:numCache>
                  <c:formatCode>General</c:formatCode>
                  <c:ptCount val="6"/>
                  <c:pt idx="0">
                    <c:v>2.7111111111111104</c:v>
                  </c:pt>
                  <c:pt idx="1">
                    <c:v>0.48888888888888832</c:v>
                  </c:pt>
                  <c:pt idx="2">
                    <c:v>1.3111111111111111</c:v>
                  </c:pt>
                  <c:pt idx="3">
                    <c:v>0.77777777777777624</c:v>
                  </c:pt>
                  <c:pt idx="4">
                    <c:v>1.7555555555555575</c:v>
                  </c:pt>
                  <c:pt idx="5">
                    <c:v>0.39999999999999619</c:v>
                  </c:pt>
                </c:numCache>
              </c:numRef>
            </c:plus>
            <c:minus>
              <c:numRef>
                <c:f>'[SaOS-2 Kombination AUY322 + VE821.xlsx]DiOC'!$H$49:$M$49</c:f>
                <c:numCache>
                  <c:formatCode>General</c:formatCode>
                  <c:ptCount val="6"/>
                  <c:pt idx="0">
                    <c:v>2.7111111111111104</c:v>
                  </c:pt>
                  <c:pt idx="1">
                    <c:v>0.48888888888888832</c:v>
                  </c:pt>
                  <c:pt idx="2">
                    <c:v>1.3111111111111111</c:v>
                  </c:pt>
                  <c:pt idx="3">
                    <c:v>0.77777777777777624</c:v>
                  </c:pt>
                  <c:pt idx="4">
                    <c:v>1.7555555555555575</c:v>
                  </c:pt>
                  <c:pt idx="5">
                    <c:v>0.39999999999999619</c:v>
                  </c:pt>
                </c:numCache>
              </c:numRef>
            </c:minus>
          </c:errBars>
          <c:xVal>
            <c:numRef>
              <c:f>'[SaOS-2 Kombination AUY322 + VE821.xlsx]DiOC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VE821.xlsx]DiOC'!$H$43:$M$43</c:f>
              <c:numCache>
                <c:formatCode>0.00</c:formatCode>
                <c:ptCount val="6"/>
                <c:pt idx="0">
                  <c:v>11.433333333333332</c:v>
                </c:pt>
                <c:pt idx="1">
                  <c:v>16.166666666666668</c:v>
                </c:pt>
                <c:pt idx="2">
                  <c:v>24.566666666666666</c:v>
                </c:pt>
                <c:pt idx="3">
                  <c:v>51.633333333333333</c:v>
                </c:pt>
                <c:pt idx="4">
                  <c:v>58.766666666666673</c:v>
                </c:pt>
                <c:pt idx="5">
                  <c:v>57.7000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90B-459E-89A0-33F62D45816D}"/>
            </c:ext>
          </c:extLst>
        </c:ser>
        <c:ser>
          <c:idx val="1"/>
          <c:order val="1"/>
          <c:tx>
            <c:v>2 µM VE821</c:v>
          </c:tx>
          <c:spPr>
            <a:ln w="9525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VE821.xlsx]DiOC'!$H$50:$M$50</c:f>
                <c:numCache>
                  <c:formatCode>General</c:formatCode>
                  <c:ptCount val="6"/>
                  <c:pt idx="0">
                    <c:v>2.0444444444444438</c:v>
                  </c:pt>
                  <c:pt idx="1">
                    <c:v>2.9777777777777779</c:v>
                  </c:pt>
                  <c:pt idx="2">
                    <c:v>2.7111111111111108</c:v>
                  </c:pt>
                  <c:pt idx="3">
                    <c:v>2.0222222222222235</c:v>
                  </c:pt>
                  <c:pt idx="4">
                    <c:v>1.31111111111111</c:v>
                  </c:pt>
                  <c:pt idx="5">
                    <c:v>2.2444444444444449</c:v>
                  </c:pt>
                </c:numCache>
              </c:numRef>
            </c:plus>
            <c:minus>
              <c:numRef>
                <c:f>'[SaOS-2 Kombination AUY322 + VE821.xlsx]DiOC'!$H$50:$M$50</c:f>
                <c:numCache>
                  <c:formatCode>General</c:formatCode>
                  <c:ptCount val="6"/>
                  <c:pt idx="0">
                    <c:v>2.0444444444444438</c:v>
                  </c:pt>
                  <c:pt idx="1">
                    <c:v>2.9777777777777779</c:v>
                  </c:pt>
                  <c:pt idx="2">
                    <c:v>2.7111111111111108</c:v>
                  </c:pt>
                  <c:pt idx="3">
                    <c:v>2.0222222222222235</c:v>
                  </c:pt>
                  <c:pt idx="4">
                    <c:v>1.31111111111111</c:v>
                  </c:pt>
                  <c:pt idx="5">
                    <c:v>2.2444444444444449</c:v>
                  </c:pt>
                </c:numCache>
              </c:numRef>
            </c:minus>
          </c:errBars>
          <c:xVal>
            <c:numRef>
              <c:f>'[SaOS-2 Kombination AUY322 + VE821.xlsx]DiOC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VE821.xlsx]DiOC'!$H$44:$M$44</c:f>
              <c:numCache>
                <c:formatCode>0.00</c:formatCode>
                <c:ptCount val="6"/>
                <c:pt idx="0">
                  <c:v>18.166666666666668</c:v>
                </c:pt>
                <c:pt idx="1">
                  <c:v>27.066666666666663</c:v>
                </c:pt>
                <c:pt idx="2">
                  <c:v>45.066666666666663</c:v>
                </c:pt>
                <c:pt idx="3">
                  <c:v>57.733333333333327</c:v>
                </c:pt>
                <c:pt idx="4">
                  <c:v>62.233333333333327</c:v>
                </c:pt>
                <c:pt idx="5">
                  <c:v>64.43333333333333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90B-459E-89A0-33F62D45816D}"/>
            </c:ext>
          </c:extLst>
        </c:ser>
        <c:ser>
          <c:idx val="2"/>
          <c:order val="2"/>
          <c:tx>
            <c:v>5 µM VE281</c:v>
          </c:tx>
          <c:spPr>
            <a:ln w="9525">
              <a:solidFill>
                <a:srgbClr val="FF0000"/>
              </a:solidFill>
            </a:ln>
          </c:spPr>
          <c:marker>
            <c:symbol val="square"/>
            <c:size val="5"/>
            <c:spPr>
              <a:noFill/>
              <a:ln w="19050"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VE821.xlsx]DiOC'!$H$51:$M$51</c:f>
                <c:numCache>
                  <c:formatCode>General</c:formatCode>
                  <c:ptCount val="6"/>
                  <c:pt idx="0">
                    <c:v>2.0000000000000013</c:v>
                  </c:pt>
                  <c:pt idx="1">
                    <c:v>1.1333333333333304</c:v>
                  </c:pt>
                  <c:pt idx="2">
                    <c:v>0.97777777777777908</c:v>
                  </c:pt>
                  <c:pt idx="3">
                    <c:v>2.177777777777782</c:v>
                  </c:pt>
                  <c:pt idx="4">
                    <c:v>1.2666666666666657</c:v>
                  </c:pt>
                  <c:pt idx="5">
                    <c:v>1.3333333333333333</c:v>
                  </c:pt>
                </c:numCache>
              </c:numRef>
            </c:plus>
            <c:minus>
              <c:numRef>
                <c:f>'[SaOS-2 Kombination AUY322 + VE821.xlsx]DiOC'!$H$51:$M$51</c:f>
                <c:numCache>
                  <c:formatCode>General</c:formatCode>
                  <c:ptCount val="6"/>
                  <c:pt idx="0">
                    <c:v>2.0000000000000013</c:v>
                  </c:pt>
                  <c:pt idx="1">
                    <c:v>1.1333333333333304</c:v>
                  </c:pt>
                  <c:pt idx="2">
                    <c:v>0.97777777777777908</c:v>
                  </c:pt>
                  <c:pt idx="3">
                    <c:v>2.177777777777782</c:v>
                  </c:pt>
                  <c:pt idx="4">
                    <c:v>1.2666666666666657</c:v>
                  </c:pt>
                  <c:pt idx="5">
                    <c:v>1.3333333333333333</c:v>
                  </c:pt>
                </c:numCache>
              </c:numRef>
            </c:minus>
          </c:errBars>
          <c:xVal>
            <c:numRef>
              <c:f>'[SaOS-2 Kombination AUY322 + VE821.xlsx]DiOC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VE821.xlsx]DiOC'!$H$45:$M$45</c:f>
              <c:numCache>
                <c:formatCode>0.00</c:formatCode>
                <c:ptCount val="6"/>
                <c:pt idx="0">
                  <c:v>29.2</c:v>
                </c:pt>
                <c:pt idx="1">
                  <c:v>43.699999999999996</c:v>
                </c:pt>
                <c:pt idx="2">
                  <c:v>56.066666666666663</c:v>
                </c:pt>
                <c:pt idx="3">
                  <c:v>66.266666666666666</c:v>
                </c:pt>
                <c:pt idx="4">
                  <c:v>69.2</c:v>
                </c:pt>
                <c:pt idx="5">
                  <c:v>7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90B-459E-89A0-33F62D4581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555008"/>
        <c:axId val="96556928"/>
      </c:scatterChart>
      <c:valAx>
        <c:axId val="96555008"/>
        <c:scaling>
          <c:orientation val="minMax"/>
          <c:max val="6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96556928"/>
        <c:crosses val="autoZero"/>
        <c:crossBetween val="midCat"/>
        <c:majorUnit val="15"/>
        <c:minorUnit val="4"/>
      </c:valAx>
      <c:valAx>
        <c:axId val="96556928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l-GR"/>
                  <a:t>ΔΨ</a:t>
                </a:r>
                <a:r>
                  <a:rPr lang="en-US"/>
                  <a:t>M loss (%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96555008"/>
        <c:crosses val="autoZero"/>
        <c:crossBetween val="midCat"/>
        <c:majorUnit val="25"/>
        <c:minorUnit val="2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865157480314957"/>
          <c:y val="6.1111111111111109E-2"/>
          <c:w val="0.68489009186351701"/>
          <c:h val="0.72524059492563431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KU55933.xlsx]DiOC'!$H$49:$M$49</c:f>
                <c:numCache>
                  <c:formatCode>General</c:formatCode>
                  <c:ptCount val="6"/>
                  <c:pt idx="0">
                    <c:v>0.62222222222222234</c:v>
                  </c:pt>
                  <c:pt idx="1">
                    <c:v>2.3555555555555561</c:v>
                  </c:pt>
                  <c:pt idx="2">
                    <c:v>0.97777777777777908</c:v>
                  </c:pt>
                  <c:pt idx="3">
                    <c:v>0.42222222222221956</c:v>
                  </c:pt>
                  <c:pt idx="4">
                    <c:v>1.3111111111111124</c:v>
                  </c:pt>
                  <c:pt idx="5">
                    <c:v>1.2222222222222261</c:v>
                  </c:pt>
                </c:numCache>
              </c:numRef>
            </c:plus>
            <c:minus>
              <c:numRef>
                <c:f>'[SaOS-2 Kombination AUY322 + KU55933.xlsx]DiOC'!$H$49:$M$49</c:f>
                <c:numCache>
                  <c:formatCode>General</c:formatCode>
                  <c:ptCount val="6"/>
                  <c:pt idx="0">
                    <c:v>0.62222222222222234</c:v>
                  </c:pt>
                  <c:pt idx="1">
                    <c:v>2.3555555555555561</c:v>
                  </c:pt>
                  <c:pt idx="2">
                    <c:v>0.97777777777777908</c:v>
                  </c:pt>
                  <c:pt idx="3">
                    <c:v>0.42222222222221956</c:v>
                  </c:pt>
                  <c:pt idx="4">
                    <c:v>1.3111111111111124</c:v>
                  </c:pt>
                  <c:pt idx="5">
                    <c:v>1.2222222222222261</c:v>
                  </c:pt>
                </c:numCache>
              </c:numRef>
            </c:minus>
          </c:errBars>
          <c:xVal>
            <c:numRef>
              <c:f>'[SaOS-2 Kombination AUY322 + KU55933.xlsx]DiOC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KU55933.xlsx]DiOC'!$H$43:$M$43</c:f>
              <c:numCache>
                <c:formatCode>0.00</c:formatCode>
                <c:ptCount val="6"/>
                <c:pt idx="0">
                  <c:v>8.9666666666666668</c:v>
                </c:pt>
                <c:pt idx="1">
                  <c:v>14.033333333333333</c:v>
                </c:pt>
                <c:pt idx="2">
                  <c:v>23.133333333333336</c:v>
                </c:pt>
                <c:pt idx="3">
                  <c:v>51.333333333333336</c:v>
                </c:pt>
                <c:pt idx="4">
                  <c:v>59.433333333333337</c:v>
                </c:pt>
                <c:pt idx="5">
                  <c:v>58.36666666666667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2A5-4B35-BF1C-41E5AB2223B3}"/>
            </c:ext>
          </c:extLst>
        </c:ser>
        <c:ser>
          <c:idx val="1"/>
          <c:order val="1"/>
          <c:tx>
            <c:v>5 µM KU55933</c:v>
          </c:tx>
          <c:spPr>
            <a:ln w="9525">
              <a:solidFill>
                <a:srgbClr val="00B05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KU55933.xlsx]DiOC'!$H$50:$M$50</c:f>
                <c:numCache>
                  <c:formatCode>General</c:formatCode>
                  <c:ptCount val="6"/>
                  <c:pt idx="0">
                    <c:v>1.7111111111111115</c:v>
                  </c:pt>
                  <c:pt idx="1">
                    <c:v>1.4666666666666661</c:v>
                  </c:pt>
                  <c:pt idx="2">
                    <c:v>1.4222222222222232</c:v>
                  </c:pt>
                  <c:pt idx="3">
                    <c:v>0.82222222222222052</c:v>
                  </c:pt>
                  <c:pt idx="4">
                    <c:v>1.288888888888889</c:v>
                  </c:pt>
                  <c:pt idx="5">
                    <c:v>0.55555555555555713</c:v>
                  </c:pt>
                </c:numCache>
              </c:numRef>
            </c:plus>
            <c:minus>
              <c:numRef>
                <c:f>'[SaOS-2 Kombination AUY322 + KU55933.xlsx]DiOC'!$H$50:$M$50</c:f>
                <c:numCache>
                  <c:formatCode>General</c:formatCode>
                  <c:ptCount val="6"/>
                  <c:pt idx="0">
                    <c:v>1.7111111111111115</c:v>
                  </c:pt>
                  <c:pt idx="1">
                    <c:v>1.4666666666666661</c:v>
                  </c:pt>
                  <c:pt idx="2">
                    <c:v>1.4222222222222232</c:v>
                  </c:pt>
                  <c:pt idx="3">
                    <c:v>0.82222222222222052</c:v>
                  </c:pt>
                  <c:pt idx="4">
                    <c:v>1.288888888888889</c:v>
                  </c:pt>
                  <c:pt idx="5">
                    <c:v>0.55555555555555713</c:v>
                  </c:pt>
                </c:numCache>
              </c:numRef>
            </c:minus>
          </c:errBars>
          <c:xVal>
            <c:numRef>
              <c:f>'[SaOS-2 Kombination AUY322 + KU55933.xlsx]DiOC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KU55933.xlsx]DiOC'!$H$44:$M$44</c:f>
              <c:numCache>
                <c:formatCode>0.00</c:formatCode>
                <c:ptCount val="6"/>
                <c:pt idx="0">
                  <c:v>15.233333333333334</c:v>
                </c:pt>
                <c:pt idx="1">
                  <c:v>20</c:v>
                </c:pt>
                <c:pt idx="2">
                  <c:v>32.366666666666667</c:v>
                </c:pt>
                <c:pt idx="3">
                  <c:v>56.433333333333337</c:v>
                </c:pt>
                <c:pt idx="4">
                  <c:v>62.133333333333326</c:v>
                </c:pt>
                <c:pt idx="5">
                  <c:v>63.73333333333332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2A5-4B35-BF1C-41E5AB2223B3}"/>
            </c:ext>
          </c:extLst>
        </c:ser>
        <c:ser>
          <c:idx val="2"/>
          <c:order val="2"/>
          <c:tx>
            <c:v>7.5 µM KU55933</c:v>
          </c:tx>
          <c:spPr>
            <a:ln w="9525">
              <a:solidFill>
                <a:srgbClr val="00B050"/>
              </a:solidFill>
            </a:ln>
          </c:spPr>
          <c:marker>
            <c:symbol val="square"/>
            <c:size val="5"/>
            <c:spPr>
              <a:noFill/>
              <a:ln w="19050"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KU55933.xlsx]DiOC'!$H$51:$M$51</c:f>
                <c:numCache>
                  <c:formatCode>General</c:formatCode>
                  <c:ptCount val="6"/>
                  <c:pt idx="0">
                    <c:v>2.0888888888888886</c:v>
                  </c:pt>
                  <c:pt idx="1">
                    <c:v>2.6666666666666665</c:v>
                  </c:pt>
                  <c:pt idx="2">
                    <c:v>2.6666666666666665</c:v>
                  </c:pt>
                  <c:pt idx="3">
                    <c:v>4.0666666666666673</c:v>
                  </c:pt>
                  <c:pt idx="4">
                    <c:v>3.6444444444444435</c:v>
                  </c:pt>
                  <c:pt idx="5">
                    <c:v>2.2222222222222263</c:v>
                  </c:pt>
                </c:numCache>
              </c:numRef>
            </c:plus>
            <c:minus>
              <c:numRef>
                <c:f>'[SaOS-2 Kombination AUY322 + KU55933.xlsx]DiOC'!$H$51:$M$51</c:f>
                <c:numCache>
                  <c:formatCode>General</c:formatCode>
                  <c:ptCount val="6"/>
                  <c:pt idx="0">
                    <c:v>2.0888888888888886</c:v>
                  </c:pt>
                  <c:pt idx="1">
                    <c:v>2.6666666666666665</c:v>
                  </c:pt>
                  <c:pt idx="2">
                    <c:v>2.6666666666666665</c:v>
                  </c:pt>
                  <c:pt idx="3">
                    <c:v>4.0666666666666673</c:v>
                  </c:pt>
                  <c:pt idx="4">
                    <c:v>3.6444444444444435</c:v>
                  </c:pt>
                  <c:pt idx="5">
                    <c:v>2.2222222222222263</c:v>
                  </c:pt>
                </c:numCache>
              </c:numRef>
            </c:minus>
          </c:errBars>
          <c:xVal>
            <c:numRef>
              <c:f>'[SaOS-2 Kombination AUY322 + KU55933.xlsx]DiOC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KU55933.xlsx]DiOC'!$H$45:$M$45</c:f>
              <c:numCache>
                <c:formatCode>0.00</c:formatCode>
                <c:ptCount val="6"/>
                <c:pt idx="0">
                  <c:v>18.566666666666666</c:v>
                </c:pt>
                <c:pt idx="1">
                  <c:v>27.5</c:v>
                </c:pt>
                <c:pt idx="2">
                  <c:v>37.599999999999994</c:v>
                </c:pt>
                <c:pt idx="3">
                  <c:v>62.9</c:v>
                </c:pt>
                <c:pt idx="4">
                  <c:v>68.033333333333331</c:v>
                </c:pt>
                <c:pt idx="5">
                  <c:v>66.56666666666667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92A5-4B35-BF1C-41E5AB2223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3804288"/>
        <c:axId val="132797184"/>
      </c:scatterChart>
      <c:valAx>
        <c:axId val="123804288"/>
        <c:scaling>
          <c:orientation val="minMax"/>
          <c:max val="6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32797184"/>
        <c:crosses val="autoZero"/>
        <c:crossBetween val="midCat"/>
        <c:majorUnit val="15"/>
        <c:minorUnit val="4"/>
      </c:valAx>
      <c:valAx>
        <c:axId val="132797184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l-GR"/>
                  <a:t>ΔΨ</a:t>
                </a:r>
                <a:r>
                  <a:rPr lang="en-US"/>
                  <a:t>M loss (%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23804288"/>
        <c:crosses val="autoZero"/>
        <c:crossBetween val="midCat"/>
        <c:majorUnit val="25"/>
        <c:minorUnit val="2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559601924759402"/>
          <c:y val="6.1111111111111109E-2"/>
          <c:w val="0.67794564741907259"/>
          <c:h val="0.72524059492563431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KU55933.xlsx]PI'!$H$49:$M$49</c:f>
                <c:numCache>
                  <c:formatCode>General</c:formatCode>
                  <c:ptCount val="6"/>
                  <c:pt idx="0">
                    <c:v>0.80000000000000071</c:v>
                  </c:pt>
                  <c:pt idx="1">
                    <c:v>1.1111111111111107</c:v>
                  </c:pt>
                  <c:pt idx="2">
                    <c:v>1.3111111111111111</c:v>
                  </c:pt>
                  <c:pt idx="3">
                    <c:v>3.0666666666666678</c:v>
                  </c:pt>
                  <c:pt idx="4">
                    <c:v>2.5777777777777779</c:v>
                  </c:pt>
                  <c:pt idx="5">
                    <c:v>2.2444444444444422</c:v>
                  </c:pt>
                </c:numCache>
              </c:numRef>
            </c:plus>
            <c:minus>
              <c:numRef>
                <c:f>'[SaOS-2 Kombination AUY322 + KU55933.xlsx]PI'!$H$49:$M$49</c:f>
                <c:numCache>
                  <c:formatCode>General</c:formatCode>
                  <c:ptCount val="6"/>
                  <c:pt idx="0">
                    <c:v>0.80000000000000071</c:v>
                  </c:pt>
                  <c:pt idx="1">
                    <c:v>1.1111111111111107</c:v>
                  </c:pt>
                  <c:pt idx="2">
                    <c:v>1.3111111111111111</c:v>
                  </c:pt>
                  <c:pt idx="3">
                    <c:v>3.0666666666666678</c:v>
                  </c:pt>
                  <c:pt idx="4">
                    <c:v>2.5777777777777779</c:v>
                  </c:pt>
                  <c:pt idx="5">
                    <c:v>2.2444444444444422</c:v>
                  </c:pt>
                </c:numCache>
              </c:numRef>
            </c:minus>
          </c:errBars>
          <c:xVal>
            <c:numRef>
              <c:f>'[SaOS-2 Kombination AUY322 + KU55933.xlsx]PI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KU55933.xlsx]PI'!$H$43:$M$43</c:f>
              <c:numCache>
                <c:formatCode>0.00</c:formatCode>
                <c:ptCount val="6"/>
                <c:pt idx="0">
                  <c:v>10.200000000000001</c:v>
                </c:pt>
                <c:pt idx="1">
                  <c:v>13.966666666666667</c:v>
                </c:pt>
                <c:pt idx="2">
                  <c:v>20.566666666666666</c:v>
                </c:pt>
                <c:pt idx="3">
                  <c:v>33.6</c:v>
                </c:pt>
                <c:pt idx="4">
                  <c:v>39.133333333333333</c:v>
                </c:pt>
                <c:pt idx="5">
                  <c:v>40.26666666666667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CE8-4677-8A4D-E680DB394BAC}"/>
            </c:ext>
          </c:extLst>
        </c:ser>
        <c:ser>
          <c:idx val="1"/>
          <c:order val="1"/>
          <c:tx>
            <c:v>5 µM KU55933</c:v>
          </c:tx>
          <c:spPr>
            <a:ln w="9525">
              <a:solidFill>
                <a:srgbClr val="00B05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KU55933.xlsx]PI'!$H$50:$M$50</c:f>
                <c:numCache>
                  <c:formatCode>General</c:formatCode>
                  <c:ptCount val="6"/>
                  <c:pt idx="0">
                    <c:v>0.66666666666666663</c:v>
                  </c:pt>
                  <c:pt idx="1">
                    <c:v>1.7333333333333325</c:v>
                  </c:pt>
                  <c:pt idx="2">
                    <c:v>1.1777777777777771</c:v>
                  </c:pt>
                  <c:pt idx="3">
                    <c:v>1.022222222222221</c:v>
                  </c:pt>
                  <c:pt idx="4">
                    <c:v>2.6888888888888878</c:v>
                  </c:pt>
                  <c:pt idx="5">
                    <c:v>2.5999999999999992</c:v>
                  </c:pt>
                </c:numCache>
              </c:numRef>
            </c:plus>
            <c:minus>
              <c:numRef>
                <c:f>'[SaOS-2 Kombination AUY322 + KU55933.xlsx]PI'!$H$50:$M$50</c:f>
                <c:numCache>
                  <c:formatCode>General</c:formatCode>
                  <c:ptCount val="6"/>
                  <c:pt idx="0">
                    <c:v>0.66666666666666663</c:v>
                  </c:pt>
                  <c:pt idx="1">
                    <c:v>1.7333333333333325</c:v>
                  </c:pt>
                  <c:pt idx="2">
                    <c:v>1.1777777777777771</c:v>
                  </c:pt>
                  <c:pt idx="3">
                    <c:v>1.022222222222221</c:v>
                  </c:pt>
                  <c:pt idx="4">
                    <c:v>2.6888888888888878</c:v>
                  </c:pt>
                  <c:pt idx="5">
                    <c:v>2.5999999999999992</c:v>
                  </c:pt>
                </c:numCache>
              </c:numRef>
            </c:minus>
          </c:errBars>
          <c:xVal>
            <c:numRef>
              <c:f>'[SaOS-2 Kombination AUY322 + KU55933.xlsx]PI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KU55933.xlsx]PI'!$H$44:$M$44</c:f>
              <c:numCache>
                <c:formatCode>0.00</c:formatCode>
                <c:ptCount val="6"/>
                <c:pt idx="0">
                  <c:v>15.899999999999999</c:v>
                </c:pt>
                <c:pt idx="1">
                  <c:v>17.099999999999998</c:v>
                </c:pt>
                <c:pt idx="2">
                  <c:v>24.666666666666668</c:v>
                </c:pt>
                <c:pt idx="3">
                  <c:v>38.866666666666667</c:v>
                </c:pt>
                <c:pt idx="4">
                  <c:v>42.233333333333334</c:v>
                </c:pt>
                <c:pt idx="5">
                  <c:v>43.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CE8-4677-8A4D-E680DB394BAC}"/>
            </c:ext>
          </c:extLst>
        </c:ser>
        <c:ser>
          <c:idx val="2"/>
          <c:order val="2"/>
          <c:tx>
            <c:v>7.5 µM KU55933</c:v>
          </c:tx>
          <c:spPr>
            <a:ln w="9525">
              <a:solidFill>
                <a:srgbClr val="00B050"/>
              </a:solidFill>
            </a:ln>
          </c:spPr>
          <c:marker>
            <c:symbol val="square"/>
            <c:size val="5"/>
            <c:spPr>
              <a:noFill/>
              <a:ln w="19050"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SaOS-2 Kombination AUY322 + KU55933.xlsx]PI'!$H$51:$M$51</c:f>
                <c:numCache>
                  <c:formatCode>General</c:formatCode>
                  <c:ptCount val="6"/>
                  <c:pt idx="0">
                    <c:v>2.3111111111111113</c:v>
                  </c:pt>
                  <c:pt idx="1">
                    <c:v>2.8888888888888893</c:v>
                  </c:pt>
                  <c:pt idx="2">
                    <c:v>2.5111111111111115</c:v>
                  </c:pt>
                  <c:pt idx="3">
                    <c:v>4.1777777777777771</c:v>
                  </c:pt>
                  <c:pt idx="4">
                    <c:v>5.644444444444443</c:v>
                  </c:pt>
                  <c:pt idx="5">
                    <c:v>2.7777777777777763</c:v>
                  </c:pt>
                </c:numCache>
              </c:numRef>
            </c:plus>
            <c:minus>
              <c:numRef>
                <c:f>'[SaOS-2 Kombination AUY322 + KU55933.xlsx]PI'!$H$51:$M$51</c:f>
                <c:numCache>
                  <c:formatCode>General</c:formatCode>
                  <c:ptCount val="6"/>
                  <c:pt idx="0">
                    <c:v>2.3111111111111113</c:v>
                  </c:pt>
                  <c:pt idx="1">
                    <c:v>2.8888888888888893</c:v>
                  </c:pt>
                  <c:pt idx="2">
                    <c:v>2.5111111111111115</c:v>
                  </c:pt>
                  <c:pt idx="3">
                    <c:v>4.1777777777777771</c:v>
                  </c:pt>
                  <c:pt idx="4">
                    <c:v>5.644444444444443</c:v>
                  </c:pt>
                  <c:pt idx="5">
                    <c:v>2.7777777777777763</c:v>
                  </c:pt>
                </c:numCache>
              </c:numRef>
            </c:minus>
          </c:errBars>
          <c:xVal>
            <c:numRef>
              <c:f>'[SaOS-2 Kombination AUY322 + KU55933.xlsx]PI'!$H$42:$M$42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xVal>
          <c:yVal>
            <c:numRef>
              <c:f>'[SaOS-2 Kombination AUY322 + KU55933.xlsx]PI'!$H$45:$M$45</c:f>
              <c:numCache>
                <c:formatCode>0.00</c:formatCode>
                <c:ptCount val="6"/>
                <c:pt idx="0">
                  <c:v>17.233333333333334</c:v>
                </c:pt>
                <c:pt idx="1">
                  <c:v>22.466666666666669</c:v>
                </c:pt>
                <c:pt idx="2">
                  <c:v>27.866666666666664</c:v>
                </c:pt>
                <c:pt idx="3">
                  <c:v>42.633333333333333</c:v>
                </c:pt>
                <c:pt idx="4">
                  <c:v>47.533333333333331</c:v>
                </c:pt>
                <c:pt idx="5">
                  <c:v>47.13333333333333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1CE8-4677-8A4D-E680DB394B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4379776"/>
        <c:axId val="154382336"/>
      </c:scatterChart>
      <c:valAx>
        <c:axId val="154379776"/>
        <c:scaling>
          <c:orientation val="minMax"/>
          <c:max val="6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54382336"/>
        <c:crosses val="autoZero"/>
        <c:crossBetween val="midCat"/>
        <c:majorUnit val="15"/>
        <c:minorUnit val="4"/>
      </c:valAx>
      <c:valAx>
        <c:axId val="154382336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death (%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54379776"/>
        <c:crosses val="autoZero"/>
        <c:crossBetween val="midCat"/>
        <c:majorUnit val="25"/>
        <c:minorUnit val="2"/>
      </c:valAx>
    </c:plotArea>
    <c:legend>
      <c:legendPos val="r"/>
      <c:layout>
        <c:manualLayout>
          <c:xMode val="edge"/>
          <c:yMode val="edge"/>
          <c:x val="0.20751603966170895"/>
          <c:y val="3.8907844852726747E-2"/>
          <c:w val="0.79248396033829083"/>
          <c:h val="0.1999620880723243"/>
        </c:manualLayout>
      </c:layout>
      <c:overlay val="1"/>
    </c:legend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2454</cdr:x>
      <cdr:y>0.04398</cdr:y>
    </cdr:from>
    <cdr:to>
      <cdr:x>0.47454</cdr:x>
      <cdr:y>0.2475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07975" y="60325"/>
          <a:ext cx="342900" cy="2792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600" b="0" dirty="0">
              <a:latin typeface="Arial" panose="020B0604020202020204" pitchFamily="34" charset="0"/>
              <a:cs typeface="Arial" panose="020B0604020202020204" pitchFamily="34" charset="0"/>
            </a:rPr>
            <a:t>48 h</a:t>
          </a:r>
        </a:p>
        <a:p xmlns:a="http://schemas.openxmlformats.org/drawingml/2006/main">
          <a:pPr algn="ctr"/>
          <a:r>
            <a:rPr lang="en-US" sz="600" b="0" dirty="0">
              <a:latin typeface="Arial" panose="020B0604020202020204" pitchFamily="34" charset="0"/>
              <a:cs typeface="Arial" panose="020B0604020202020204" pitchFamily="34" charset="0"/>
            </a:rPr>
            <a:t>SaOS-2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5</cdr:x>
      <cdr:y>0.02342</cdr:y>
    </cdr:from>
    <cdr:to>
      <cdr:x>0.5</cdr:x>
      <cdr:y>0.20195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342900" y="32127"/>
          <a:ext cx="342900" cy="24487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600" b="0" dirty="0">
              <a:latin typeface="Arial" panose="020B0604020202020204" pitchFamily="34" charset="0"/>
              <a:cs typeface="Arial" panose="020B0604020202020204" pitchFamily="34" charset="0"/>
            </a:rPr>
            <a:t>48 h</a:t>
          </a:r>
        </a:p>
        <a:p xmlns:a="http://schemas.openxmlformats.org/drawingml/2006/main">
          <a:pPr algn="ctr"/>
          <a:r>
            <a:rPr lang="en-US" sz="600" b="0" dirty="0">
              <a:latin typeface="Arial" panose="020B0604020202020204" pitchFamily="34" charset="0"/>
              <a:cs typeface="Arial" panose="020B0604020202020204" pitchFamily="34" charset="0"/>
            </a:rPr>
            <a:t>SaOS-2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eg"/><Relationship Id="rId13" Type="http://schemas.openxmlformats.org/officeDocument/2006/relationships/image" Target="../media/image8.png"/><Relationship Id="rId18" Type="http://schemas.openxmlformats.org/officeDocument/2006/relationships/image" Target="../media/image13.png"/><Relationship Id="rId26" Type="http://schemas.openxmlformats.org/officeDocument/2006/relationships/image" Target="../media/image21.png"/><Relationship Id="rId3" Type="http://schemas.openxmlformats.org/officeDocument/2006/relationships/chart" Target="../charts/chart2.xml"/><Relationship Id="rId21" Type="http://schemas.openxmlformats.org/officeDocument/2006/relationships/image" Target="../media/image16.png"/><Relationship Id="rId7" Type="http://schemas.openxmlformats.org/officeDocument/2006/relationships/image" Target="../media/image2.png"/><Relationship Id="rId12" Type="http://schemas.openxmlformats.org/officeDocument/2006/relationships/image" Target="../media/image7.jpeg"/><Relationship Id="rId17" Type="http://schemas.openxmlformats.org/officeDocument/2006/relationships/image" Target="../media/image12.jpeg"/><Relationship Id="rId25" Type="http://schemas.openxmlformats.org/officeDocument/2006/relationships/image" Target="../media/image20.png"/><Relationship Id="rId2" Type="http://schemas.openxmlformats.org/officeDocument/2006/relationships/chart" Target="../charts/chart1.xml"/><Relationship Id="rId16" Type="http://schemas.openxmlformats.org/officeDocument/2006/relationships/image" Target="../media/image11.jpeg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jpeg"/><Relationship Id="rId11" Type="http://schemas.openxmlformats.org/officeDocument/2006/relationships/image" Target="../media/image6.png"/><Relationship Id="rId24" Type="http://schemas.openxmlformats.org/officeDocument/2006/relationships/image" Target="../media/image19.png"/><Relationship Id="rId5" Type="http://schemas.openxmlformats.org/officeDocument/2006/relationships/chart" Target="../charts/chart4.xml"/><Relationship Id="rId15" Type="http://schemas.openxmlformats.org/officeDocument/2006/relationships/image" Target="../media/image10.png"/><Relationship Id="rId23" Type="http://schemas.openxmlformats.org/officeDocument/2006/relationships/image" Target="../media/image18.png"/><Relationship Id="rId10" Type="http://schemas.openxmlformats.org/officeDocument/2006/relationships/image" Target="../media/image5.png"/><Relationship Id="rId19" Type="http://schemas.openxmlformats.org/officeDocument/2006/relationships/image" Target="../media/image14.jpeg"/><Relationship Id="rId4" Type="http://schemas.openxmlformats.org/officeDocument/2006/relationships/chart" Target="../charts/chart3.xml"/><Relationship Id="rId9" Type="http://schemas.openxmlformats.org/officeDocument/2006/relationships/image" Target="../media/image4.png"/><Relationship Id="rId14" Type="http://schemas.openxmlformats.org/officeDocument/2006/relationships/image" Target="../media/image9.png"/><Relationship Id="rId22" Type="http://schemas.openxmlformats.org/officeDocument/2006/relationships/image" Target="../media/image17.jpeg"/><Relationship Id="rId27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2">
            <a:extLst>
              <a:ext uri="{FF2B5EF4-FFF2-40B4-BE49-F238E27FC236}">
                <a16:creationId xmlns="" xmlns:a16="http://schemas.microsoft.com/office/drawing/2014/main" id="{2E3B26E0-94D0-6B4E-910B-406F52AF33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8201005"/>
              </p:ext>
            </p:extLst>
          </p:nvPr>
        </p:nvGraphicFramePr>
        <p:xfrm>
          <a:off x="1895216" y="1524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3">
            <a:extLst>
              <a:ext uri="{FF2B5EF4-FFF2-40B4-BE49-F238E27FC236}">
                <a16:creationId xmlns="" xmlns:a16="http://schemas.microsoft.com/office/drawing/2014/main" id="{3B32D00C-A1CD-C64F-B2B0-9B639B1A81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6464624"/>
              </p:ext>
            </p:extLst>
          </p:nvPr>
        </p:nvGraphicFramePr>
        <p:xfrm>
          <a:off x="340775" y="1524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4">
            <a:extLst>
              <a:ext uri="{FF2B5EF4-FFF2-40B4-BE49-F238E27FC236}">
                <a16:creationId xmlns="" xmlns:a16="http://schemas.microsoft.com/office/drawing/2014/main" id="{35E7C994-29B4-B549-AD98-0C90A29E07EC}"/>
              </a:ext>
            </a:extLst>
          </p:cNvPr>
          <p:cNvSpPr txBox="1"/>
          <p:nvPr/>
        </p:nvSpPr>
        <p:spPr>
          <a:xfrm>
            <a:off x="148621" y="139004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5">
            <a:extLst>
              <a:ext uri="{FF2B5EF4-FFF2-40B4-BE49-F238E27FC236}">
                <a16:creationId xmlns="" xmlns:a16="http://schemas.microsoft.com/office/drawing/2014/main" id="{27264BA5-F823-2248-927B-E31E9756215D}"/>
              </a:ext>
            </a:extLst>
          </p:cNvPr>
          <p:cNvSpPr txBox="1"/>
          <p:nvPr/>
        </p:nvSpPr>
        <p:spPr>
          <a:xfrm>
            <a:off x="3276600" y="13855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6" name="Chart 6">
            <a:extLst>
              <a:ext uri="{FF2B5EF4-FFF2-40B4-BE49-F238E27FC236}">
                <a16:creationId xmlns="" xmlns:a16="http://schemas.microsoft.com/office/drawing/2014/main" id="{EB4B2CBC-CCC9-9943-90BB-C8312867CC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9879707"/>
              </p:ext>
            </p:extLst>
          </p:nvPr>
        </p:nvGraphicFramePr>
        <p:xfrm>
          <a:off x="3465229" y="1524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7">
            <a:extLst>
              <a:ext uri="{FF2B5EF4-FFF2-40B4-BE49-F238E27FC236}">
                <a16:creationId xmlns="" xmlns:a16="http://schemas.microsoft.com/office/drawing/2014/main" id="{AC3AE480-84EC-FD4D-9E4E-D6EABD3B2C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8078190"/>
              </p:ext>
            </p:extLst>
          </p:nvPr>
        </p:nvGraphicFramePr>
        <p:xfrm>
          <a:off x="4800600" y="1524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56" name="Group 55"/>
          <p:cNvGrpSpPr/>
          <p:nvPr/>
        </p:nvGrpSpPr>
        <p:grpSpPr>
          <a:xfrm>
            <a:off x="2654191" y="3160716"/>
            <a:ext cx="1977022" cy="2574288"/>
            <a:chOff x="395818" y="4724385"/>
            <a:chExt cx="1977022" cy="2574288"/>
          </a:xfrm>
        </p:grpSpPr>
        <p:sp>
          <p:nvSpPr>
            <p:cNvPr id="16" name="TextBox 15"/>
            <p:cNvSpPr txBox="1"/>
            <p:nvPr/>
          </p:nvSpPr>
          <p:spPr>
            <a:xfrm>
              <a:off x="1441721" y="7114007"/>
              <a:ext cx="53732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4 h A673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95818" y="4734802"/>
              <a:ext cx="7088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 </a:t>
              </a:r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AUY922</a:t>
              </a:r>
            </a:p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E821 (µM)</a:t>
              </a:r>
            </a:p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KU55933 (µM)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76578" y="5149334"/>
              <a:ext cx="4283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R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69292" y="5334000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TR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076840" y="4729695"/>
              <a:ext cx="2103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73371" y="5736802"/>
              <a:ext cx="43473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CHK1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218249" y="4734802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6800" y="5105156"/>
              <a:ext cx="1296000" cy="228844"/>
            </a:xfrm>
            <a:prstGeom prst="rect">
              <a:avLst/>
            </a:prstGeom>
          </p:spPr>
        </p:pic>
        <p:sp>
          <p:nvSpPr>
            <p:cNvPr id="47" name="TextBox 46"/>
            <p:cNvSpPr txBox="1"/>
            <p:nvPr/>
          </p:nvSpPr>
          <p:spPr>
            <a:xfrm>
              <a:off x="1379118" y="4731973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6800" y="5348264"/>
              <a:ext cx="1296000" cy="151034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6800" y="5747510"/>
              <a:ext cx="1296000" cy="166081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6800" y="5931469"/>
              <a:ext cx="1296000" cy="187761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6800" y="6139232"/>
              <a:ext cx="1296000" cy="1620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6800" y="5513562"/>
              <a:ext cx="1296000" cy="179098"/>
            </a:xfrm>
            <a:prstGeom prst="rect">
              <a:avLst/>
            </a:prstGeom>
          </p:spPr>
        </p:pic>
        <p:sp>
          <p:nvSpPr>
            <p:cNvPr id="51" name="TextBox 50"/>
            <p:cNvSpPr txBox="1"/>
            <p:nvPr/>
          </p:nvSpPr>
          <p:spPr>
            <a:xfrm>
              <a:off x="613826" y="5530334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615472" y="6137108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sp>
          <p:nvSpPr>
            <p:cNvPr id="53" name="TextBox 11">
              <a:extLst>
                <a:ext uri="{FF2B5EF4-FFF2-40B4-BE49-F238E27FC236}">
                  <a16:creationId xmlns="" xmlns:a16="http://schemas.microsoft.com/office/drawing/2014/main" id="{8E8E1D32-38A9-C549-8467-AD2B83BDAD8C}"/>
                </a:ext>
              </a:extLst>
            </p:cNvPr>
            <p:cNvSpPr txBox="1"/>
            <p:nvPr/>
          </p:nvSpPr>
          <p:spPr>
            <a:xfrm>
              <a:off x="673371" y="6934200"/>
              <a:ext cx="4251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6800" y="6346519"/>
              <a:ext cx="1296000" cy="172712"/>
            </a:xfrm>
            <a:prstGeom prst="rect">
              <a:avLst/>
            </a:prstGeom>
          </p:spPr>
        </p:pic>
        <p:sp>
          <p:nvSpPr>
            <p:cNvPr id="55" name="TextBox 54"/>
            <p:cNvSpPr txBox="1"/>
            <p:nvPr/>
          </p:nvSpPr>
          <p:spPr>
            <a:xfrm>
              <a:off x="707034" y="5952442"/>
              <a:ext cx="3914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HK1</a:t>
              </a:r>
            </a:p>
          </p:txBody>
        </p:sp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6800" y="6537414"/>
              <a:ext cx="1296000" cy="194400"/>
            </a:xfrm>
            <a:prstGeom prst="rect">
              <a:avLst/>
            </a:prstGeom>
          </p:spPr>
        </p:pic>
        <p:sp>
          <p:nvSpPr>
            <p:cNvPr id="57" name="TextBox 56"/>
            <p:cNvSpPr txBox="1"/>
            <p:nvPr/>
          </p:nvSpPr>
          <p:spPr>
            <a:xfrm>
              <a:off x="715049" y="6346004"/>
              <a:ext cx="3898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M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65284" y="6549581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TM</a:t>
              </a:r>
            </a:p>
          </p:txBody>
        </p:sp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4685" y="6750725"/>
              <a:ext cx="1296000" cy="179098"/>
            </a:xfrm>
            <a:prstGeom prst="rect">
              <a:avLst/>
            </a:prstGeom>
          </p:spPr>
        </p:pic>
        <p:sp>
          <p:nvSpPr>
            <p:cNvPr id="60" name="TextBox 59"/>
            <p:cNvSpPr txBox="1"/>
            <p:nvPr/>
          </p:nvSpPr>
          <p:spPr>
            <a:xfrm>
              <a:off x="713446" y="6750725"/>
              <a:ext cx="3914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HK2</a:t>
              </a:r>
            </a:p>
          </p:txBody>
        </p:sp>
        <p:pic>
          <p:nvPicPr>
            <p:cNvPr id="54" name="Picture 53"/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62385" y="6954302"/>
              <a:ext cx="1296000" cy="159705"/>
            </a:xfrm>
            <a:prstGeom prst="rect">
              <a:avLst/>
            </a:prstGeom>
          </p:spPr>
        </p:pic>
        <p:cxnSp>
          <p:nvCxnSpPr>
            <p:cNvPr id="62" name="Straight Connector 61"/>
            <p:cNvCxnSpPr/>
            <p:nvPr/>
          </p:nvCxnSpPr>
          <p:spPr>
            <a:xfrm>
              <a:off x="1872000" y="5116660"/>
              <a:ext cx="0" cy="576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1872000" y="5784600"/>
              <a:ext cx="0" cy="504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1836000" y="6358200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1440000" y="5099027"/>
              <a:ext cx="0" cy="576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>
              <a:off x="1440000" y="5784600"/>
              <a:ext cx="0" cy="504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1404000" y="6340567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1523049" y="4729617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675449" y="4734533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820475" y="4727069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960210" y="4724385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101612" y="4735244"/>
              <a:ext cx="2712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grpSp>
        <p:nvGrpSpPr>
          <p:cNvPr id="122" name="Group 121"/>
          <p:cNvGrpSpPr/>
          <p:nvPr/>
        </p:nvGrpSpPr>
        <p:grpSpPr>
          <a:xfrm>
            <a:off x="385178" y="3168304"/>
            <a:ext cx="1977022" cy="2622896"/>
            <a:chOff x="2822737" y="4724570"/>
            <a:chExt cx="1977022" cy="2622896"/>
          </a:xfrm>
        </p:grpSpPr>
        <p:sp>
          <p:nvSpPr>
            <p:cNvPr id="78" name="TextBox 77"/>
            <p:cNvSpPr txBox="1"/>
            <p:nvPr/>
          </p:nvSpPr>
          <p:spPr>
            <a:xfrm>
              <a:off x="3814138" y="7162800"/>
              <a:ext cx="59182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4 h WE-68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822737" y="4734987"/>
              <a:ext cx="7088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 </a:t>
              </a:r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AUY922</a:t>
              </a:r>
            </a:p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E821 (µM)</a:t>
              </a:r>
            </a:p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KU55933 (µM)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103497" y="5149519"/>
              <a:ext cx="4283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R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196211" y="5334185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TR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503759" y="4729880"/>
              <a:ext cx="2103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3100290" y="5791200"/>
              <a:ext cx="43473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CHK1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645168" y="4734987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806037" y="4732158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040745" y="5530519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3042391" y="6139934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sp>
          <p:nvSpPr>
            <p:cNvPr id="94" name="TextBox 11">
              <a:extLst>
                <a:ext uri="{FF2B5EF4-FFF2-40B4-BE49-F238E27FC236}">
                  <a16:creationId xmlns="" xmlns:a16="http://schemas.microsoft.com/office/drawing/2014/main" id="{8E8E1D32-38A9-C549-8467-AD2B83BDAD8C}"/>
                </a:ext>
              </a:extLst>
            </p:cNvPr>
            <p:cNvSpPr txBox="1"/>
            <p:nvPr/>
          </p:nvSpPr>
          <p:spPr>
            <a:xfrm>
              <a:off x="3100290" y="6978134"/>
              <a:ext cx="4251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3133953" y="5943600"/>
              <a:ext cx="3914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HK1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3141968" y="6400800"/>
              <a:ext cx="3898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M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3192203" y="6597134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TM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140365" y="6781800"/>
              <a:ext cx="3914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HK2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3949968" y="4729802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4102368" y="4734718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4247394" y="4727254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4387129" y="4724570"/>
              <a:ext cx="2295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4528531" y="4735429"/>
              <a:ext cx="2712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pic>
          <p:nvPicPr>
            <p:cNvPr id="59" name="Picture 58"/>
            <p:cNvPicPr>
              <a:picLocks noChangeAspect="1"/>
            </p:cNvPicPr>
            <p:nvPr/>
          </p:nvPicPr>
          <p:blipFill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84798" y="5106493"/>
              <a:ext cx="1296000" cy="224507"/>
            </a:xfrm>
            <a:prstGeom prst="rect">
              <a:avLst/>
            </a:prstGeom>
          </p:spPr>
        </p:pic>
        <p:pic>
          <p:nvPicPr>
            <p:cNvPr id="61" name="Picture 60"/>
            <p:cNvPicPr>
              <a:picLocks noChangeAspect="1"/>
            </p:cNvPicPr>
            <p:nvPr/>
          </p:nvPicPr>
          <p:blipFill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89304" y="5338562"/>
              <a:ext cx="1296000" cy="190064"/>
            </a:xfrm>
            <a:prstGeom prst="rect">
              <a:avLst/>
            </a:prstGeom>
          </p:spPr>
        </p:pic>
        <p:pic>
          <p:nvPicPr>
            <p:cNvPr id="114" name="Picture 113"/>
            <p:cNvPicPr>
              <a:picLocks noChangeAspect="1"/>
            </p:cNvPicPr>
            <p:nvPr/>
          </p:nvPicPr>
          <p:blipFill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89304" y="5539448"/>
              <a:ext cx="1296000" cy="190064"/>
            </a:xfrm>
            <a:prstGeom prst="rect">
              <a:avLst/>
            </a:prstGeom>
          </p:spPr>
        </p:pic>
        <p:pic>
          <p:nvPicPr>
            <p:cNvPr id="115" name="Picture 114"/>
            <p:cNvPicPr>
              <a:picLocks noChangeAspect="1"/>
            </p:cNvPicPr>
            <p:nvPr/>
          </p:nvPicPr>
          <p:blipFill>
            <a:blip r:embed="rId1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89304" y="5781600"/>
              <a:ext cx="1296000" cy="162000"/>
            </a:xfrm>
            <a:prstGeom prst="rect">
              <a:avLst/>
            </a:prstGeom>
          </p:spPr>
        </p:pic>
        <p:pic>
          <p:nvPicPr>
            <p:cNvPr id="116" name="Picture 115"/>
            <p:cNvPicPr>
              <a:picLocks noChangeAspect="1"/>
            </p:cNvPicPr>
            <p:nvPr/>
          </p:nvPicPr>
          <p:blipFill>
            <a:blip r:embed="rId2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91604" y="5966993"/>
              <a:ext cx="1296000" cy="162000"/>
            </a:xfrm>
            <a:prstGeom prst="rect">
              <a:avLst/>
            </a:prstGeom>
          </p:spPr>
        </p:pic>
        <p:cxnSp>
          <p:nvCxnSpPr>
            <p:cNvPr id="103" name="Straight Connector 102"/>
            <p:cNvCxnSpPr/>
            <p:nvPr/>
          </p:nvCxnSpPr>
          <p:spPr>
            <a:xfrm>
              <a:off x="4267200" y="5123033"/>
              <a:ext cx="0" cy="576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>
              <a:off x="3835200" y="5105400"/>
              <a:ext cx="0" cy="576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7" name="Picture 116"/>
            <p:cNvPicPr>
              <a:picLocks noChangeAspect="1"/>
            </p:cNvPicPr>
            <p:nvPr/>
          </p:nvPicPr>
          <p:blipFill>
            <a:blip r:embed="rId2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91604" y="6159341"/>
              <a:ext cx="1296000" cy="172712"/>
            </a:xfrm>
            <a:prstGeom prst="rect">
              <a:avLst/>
            </a:prstGeom>
          </p:spPr>
        </p:pic>
        <p:cxnSp>
          <p:nvCxnSpPr>
            <p:cNvPr id="104" name="Straight Connector 103"/>
            <p:cNvCxnSpPr/>
            <p:nvPr/>
          </p:nvCxnSpPr>
          <p:spPr>
            <a:xfrm>
              <a:off x="4288465" y="5818200"/>
              <a:ext cx="0" cy="504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/>
            <p:nvPr/>
          </p:nvCxnSpPr>
          <p:spPr>
            <a:xfrm>
              <a:off x="3856465" y="5800567"/>
              <a:ext cx="0" cy="504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8" name="Picture 117"/>
            <p:cNvPicPr>
              <a:picLocks noChangeAspect="1"/>
            </p:cNvPicPr>
            <p:nvPr/>
          </p:nvPicPr>
          <p:blipFill>
            <a:blip r:embed="rId2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89304" y="6402427"/>
              <a:ext cx="1296000" cy="168380"/>
            </a:xfrm>
            <a:prstGeom prst="rect">
              <a:avLst/>
            </a:prstGeom>
          </p:spPr>
        </p:pic>
        <p:pic>
          <p:nvPicPr>
            <p:cNvPr id="119" name="Picture 118"/>
            <p:cNvPicPr>
              <a:picLocks noChangeAspect="1"/>
            </p:cNvPicPr>
            <p:nvPr/>
          </p:nvPicPr>
          <p:blipFill>
            <a:blip r:embed="rId2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91604" y="6596072"/>
              <a:ext cx="1296000" cy="185728"/>
            </a:xfrm>
            <a:prstGeom prst="rect">
              <a:avLst/>
            </a:prstGeom>
          </p:spPr>
        </p:pic>
        <p:pic>
          <p:nvPicPr>
            <p:cNvPr id="120" name="Picture 119"/>
            <p:cNvPicPr>
              <a:picLocks noChangeAspect="1"/>
            </p:cNvPicPr>
            <p:nvPr/>
          </p:nvPicPr>
          <p:blipFill>
            <a:blip r:embed="rId2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91604" y="6796895"/>
              <a:ext cx="1296000" cy="168380"/>
            </a:xfrm>
            <a:prstGeom prst="rect">
              <a:avLst/>
            </a:prstGeom>
          </p:spPr>
        </p:pic>
        <p:pic>
          <p:nvPicPr>
            <p:cNvPr id="121" name="Picture 120"/>
            <p:cNvPicPr>
              <a:picLocks noChangeAspect="1"/>
            </p:cNvPicPr>
            <p:nvPr/>
          </p:nvPicPr>
          <p:blipFill>
            <a:blip r:embed="rId2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91604" y="6990230"/>
              <a:ext cx="1296000" cy="185728"/>
            </a:xfrm>
            <a:prstGeom prst="rect">
              <a:avLst/>
            </a:prstGeom>
          </p:spPr>
        </p:pic>
        <p:cxnSp>
          <p:nvCxnSpPr>
            <p:cNvPr id="105" name="Straight Connector 104"/>
            <p:cNvCxnSpPr/>
            <p:nvPr/>
          </p:nvCxnSpPr>
          <p:spPr>
            <a:xfrm>
              <a:off x="4288465" y="6419958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3856465" y="6402325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3" name="TextBox 4">
            <a:extLst>
              <a:ext uri="{FF2B5EF4-FFF2-40B4-BE49-F238E27FC236}">
                <a16:creationId xmlns="" xmlns:a16="http://schemas.microsoft.com/office/drawing/2014/main" id="{35E7C994-29B4-B549-AD98-0C90A29E07EC}"/>
              </a:ext>
            </a:extLst>
          </p:cNvPr>
          <p:cNvSpPr txBox="1"/>
          <p:nvPr/>
        </p:nvSpPr>
        <p:spPr>
          <a:xfrm>
            <a:off x="152400" y="30529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4" name="TextBox 5">
            <a:extLst>
              <a:ext uri="{FF2B5EF4-FFF2-40B4-BE49-F238E27FC236}">
                <a16:creationId xmlns="" xmlns:a16="http://schemas.microsoft.com/office/drawing/2014/main" id="{27264BA5-F823-2248-927B-E31E9756215D}"/>
              </a:ext>
            </a:extLst>
          </p:cNvPr>
          <p:cNvSpPr txBox="1"/>
          <p:nvPr/>
        </p:nvSpPr>
        <p:spPr>
          <a:xfrm>
            <a:off x="2438400" y="305295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151854" y="714239"/>
            <a:ext cx="902644" cy="557417"/>
            <a:chOff x="883748" y="737983"/>
            <a:chExt cx="902644" cy="557417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2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61729" y="973005"/>
              <a:ext cx="324000" cy="146415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2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61729" y="1137603"/>
              <a:ext cx="324000" cy="144791"/>
            </a:xfrm>
            <a:prstGeom prst="rect">
              <a:avLst/>
            </a:prstGeom>
          </p:spPr>
        </p:pic>
        <p:sp>
          <p:nvSpPr>
            <p:cNvPr id="88" name="TextBox 11">
              <a:extLst>
                <a:ext uri="{FF2B5EF4-FFF2-40B4-BE49-F238E27FC236}">
                  <a16:creationId xmlns="" xmlns:a16="http://schemas.microsoft.com/office/drawing/2014/main" id="{8E8E1D32-38A9-C549-8467-AD2B83BDAD8C}"/>
                </a:ext>
              </a:extLst>
            </p:cNvPr>
            <p:cNvSpPr txBox="1"/>
            <p:nvPr/>
          </p:nvSpPr>
          <p:spPr>
            <a:xfrm>
              <a:off x="883748" y="1110734"/>
              <a:ext cx="4251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993089" y="94753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 rot="-2700000">
              <a:off x="1205720" y="749088"/>
              <a:ext cx="3658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673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 rot="-2700000">
              <a:off x="1366084" y="737983"/>
              <a:ext cx="4203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WE-68</a:t>
              </a:r>
            </a:p>
          </p:txBody>
        </p:sp>
      </p:grpSp>
      <p:sp>
        <p:nvSpPr>
          <p:cNvPr id="95" name="TextBox 4">
            <a:extLst>
              <a:ext uri="{FF2B5EF4-FFF2-40B4-BE49-F238E27FC236}">
                <a16:creationId xmlns="" xmlns:a16="http://schemas.microsoft.com/office/drawing/2014/main" id="{35E7C994-29B4-B549-AD98-0C90A29E07EC}"/>
              </a:ext>
            </a:extLst>
          </p:cNvPr>
          <p:cNvSpPr txBox="1"/>
          <p:nvPr/>
        </p:nvSpPr>
        <p:spPr>
          <a:xfrm>
            <a:off x="144384" y="50489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3" name="Rechteck 2">
            <a:extLst>
              <a:ext uri="{FF2B5EF4-FFF2-40B4-BE49-F238E27FC236}">
                <a16:creationId xmlns="" xmlns:a16="http://schemas.microsoft.com/office/drawing/2014/main" id="{FF445C97-254A-2640-8A5C-6B55733FC5EC}"/>
              </a:ext>
            </a:extLst>
          </p:cNvPr>
          <p:cNvSpPr/>
          <p:nvPr/>
        </p:nvSpPr>
        <p:spPr>
          <a:xfrm>
            <a:off x="267055" y="5972258"/>
            <a:ext cx="6254602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and DDR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in ES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alysis p53 expression level by Western blot. β-actin was used to control protein loading. p53 null SaOS-2 cells were treated with the indicated concentrations of AUY922, VE821, KU55933 and their combinations. DMSO was used as control. (A-C) The loss of the mitochondrial transmembrane potential (ΔΨ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cell death were assessed by flow cytometry after 48 h. All graphs show the mean ± SEM of three independent experiments. Statistical analysis was done using two-way ANOVA tests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raphPa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5; 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1; *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01). WE-68 (D) and A673 (E) cells were treated with 3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AUY922 alone and in combination with 1-5 µM of VE821 or 2-10 µM of KU55933. Analysis of indicated proteins was done by Western blot after 24 h; α-tubulin and β-actin were used to control protein loading. Immunoblots are representative of at least two independent experiment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Flowchart: Extract 99"/>
          <p:cNvSpPr/>
          <p:nvPr/>
        </p:nvSpPr>
        <p:spPr>
          <a:xfrm rot="5400000">
            <a:off x="3284895" y="3651535"/>
            <a:ext cx="33376" cy="33376"/>
          </a:xfrm>
          <a:prstGeom prst="flowChartExtra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>
              <a:ln>
                <a:solidFill>
                  <a:sysClr val="windowText" lastClr="000000"/>
                </a:solidFill>
              </a:ln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Flowchart: Extract 101"/>
          <p:cNvSpPr/>
          <p:nvPr/>
        </p:nvSpPr>
        <p:spPr>
          <a:xfrm rot="5400000">
            <a:off x="993199" y="3661523"/>
            <a:ext cx="33376" cy="33376"/>
          </a:xfrm>
          <a:prstGeom prst="flowChartExtra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>
              <a:ln>
                <a:solidFill>
                  <a:sysClr val="windowText" lastClr="000000"/>
                </a:solidFill>
              </a:ln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Right Brace 96"/>
          <p:cNvSpPr/>
          <p:nvPr/>
        </p:nvSpPr>
        <p:spPr>
          <a:xfrm>
            <a:off x="1637432" y="1946492"/>
            <a:ext cx="45719" cy="10800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Right Brace 124"/>
          <p:cNvSpPr/>
          <p:nvPr/>
        </p:nvSpPr>
        <p:spPr>
          <a:xfrm>
            <a:off x="1681343" y="1874492"/>
            <a:ext cx="45719" cy="18000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TextBox 1"/>
          <p:cNvSpPr txBox="1"/>
          <p:nvPr/>
        </p:nvSpPr>
        <p:spPr>
          <a:xfrm>
            <a:off x="1660546" y="1883647"/>
            <a:ext cx="267308" cy="16175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27" name="TextBox 1"/>
          <p:cNvSpPr txBox="1"/>
          <p:nvPr/>
        </p:nvSpPr>
        <p:spPr>
          <a:xfrm>
            <a:off x="1637692" y="1939888"/>
            <a:ext cx="267308" cy="16175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28" name="Textfeld 5">
            <a:extLst>
              <a:ext uri="{FF2B5EF4-FFF2-40B4-BE49-F238E27FC236}">
                <a16:creationId xmlns="" xmlns:a16="http://schemas.microsoft.com/office/drawing/2014/main" id="{F3494AE3-0B3B-2A43-BA6E-93CF4E233A2C}"/>
              </a:ext>
            </a:extLst>
          </p:cNvPr>
          <p:cNvSpPr txBox="1"/>
          <p:nvPr/>
        </p:nvSpPr>
        <p:spPr>
          <a:xfrm>
            <a:off x="1380943" y="24224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129" name="Textfeld 5">
            <a:extLst>
              <a:ext uri="{FF2B5EF4-FFF2-40B4-BE49-F238E27FC236}">
                <a16:creationId xmlns="" xmlns:a16="http://schemas.microsoft.com/office/drawing/2014/main" id="{F3494AE3-0B3B-2A43-BA6E-93CF4E233A2C}"/>
              </a:ext>
            </a:extLst>
          </p:cNvPr>
          <p:cNvSpPr txBox="1"/>
          <p:nvPr/>
        </p:nvSpPr>
        <p:spPr>
          <a:xfrm>
            <a:off x="2929604" y="24452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130" name="Textfeld 5">
            <a:extLst>
              <a:ext uri="{FF2B5EF4-FFF2-40B4-BE49-F238E27FC236}">
                <a16:creationId xmlns="" xmlns:a16="http://schemas.microsoft.com/office/drawing/2014/main" id="{F3494AE3-0B3B-2A43-BA6E-93CF4E233A2C}"/>
              </a:ext>
            </a:extLst>
          </p:cNvPr>
          <p:cNvSpPr txBox="1"/>
          <p:nvPr/>
        </p:nvSpPr>
        <p:spPr>
          <a:xfrm>
            <a:off x="4499153" y="24174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131" name="Textfeld 5">
            <a:extLst>
              <a:ext uri="{FF2B5EF4-FFF2-40B4-BE49-F238E27FC236}">
                <a16:creationId xmlns="" xmlns:a16="http://schemas.microsoft.com/office/drawing/2014/main" id="{F3494AE3-0B3B-2A43-BA6E-93CF4E233A2C}"/>
              </a:ext>
            </a:extLst>
          </p:cNvPr>
          <p:cNvSpPr txBox="1"/>
          <p:nvPr/>
        </p:nvSpPr>
        <p:spPr>
          <a:xfrm>
            <a:off x="5846811" y="24402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132" name="Right Brace 131"/>
          <p:cNvSpPr/>
          <p:nvPr/>
        </p:nvSpPr>
        <p:spPr>
          <a:xfrm>
            <a:off x="3186200" y="2137800"/>
            <a:ext cx="45719" cy="7200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Right Brace 132"/>
          <p:cNvSpPr/>
          <p:nvPr/>
        </p:nvSpPr>
        <p:spPr>
          <a:xfrm>
            <a:off x="3230111" y="2065800"/>
            <a:ext cx="45719" cy="14400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TextBox 1"/>
          <p:cNvSpPr txBox="1"/>
          <p:nvPr/>
        </p:nvSpPr>
        <p:spPr>
          <a:xfrm>
            <a:off x="3209314" y="2054485"/>
            <a:ext cx="267308" cy="16175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35" name="TextBox 1"/>
          <p:cNvSpPr txBox="1"/>
          <p:nvPr/>
        </p:nvSpPr>
        <p:spPr>
          <a:xfrm>
            <a:off x="3167662" y="2102894"/>
            <a:ext cx="267308" cy="16175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36" name="TextBox 1"/>
          <p:cNvSpPr txBox="1"/>
          <p:nvPr/>
        </p:nvSpPr>
        <p:spPr>
          <a:xfrm>
            <a:off x="-13746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996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0</Words>
  <Application>Microsoft Office PowerPoint</Application>
  <PresentationFormat>A4-Papier (210x297 mm)</PresentationFormat>
  <Paragraphs>10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9:52Z</dcterms:modified>
</cp:coreProperties>
</file>